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907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4631F8-F796-49A2-848E-618F9C47164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0F7693-27FE-4434-85AA-1CDDF1B1841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5753A1-98E4-4B4B-8BB5-DF665A3B3A4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0964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52428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9500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0964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52428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40AE76-9CD9-471E-9438-A416E25E6F8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8AAC9C-68F7-4693-A15B-F9FDE9804AC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F0821E-2CD9-491F-B4F5-3409BC8C172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42A2E4-16FB-4F3B-AE7A-68A34FE7628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39A10F-8C31-48F5-BCB8-9515C486CFD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95000" y="274320"/>
            <a:ext cx="8915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218CFF-5FDD-4FE2-842E-A1AE508FA69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C2832F-82F4-4993-A879-F278F87E197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700795-81A9-441F-B92F-ABDA2116233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900283-3F14-499B-9B49-9338EF4EBEE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95360" y="6244920"/>
            <a:ext cx="231120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384360" y="6244920"/>
            <a:ext cx="313668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098840" y="6244920"/>
            <a:ext cx="231156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9398D23-A82E-4B3D-B5C7-20489C1C7D65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2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910800" y="933480"/>
            <a:ext cx="7697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M    1     2     3     4     5    6     </a:t>
            </a:r>
            <a:r>
              <a:rPr b="0" lang="en-US" sz="1100" spc="-1" strike="noStrike" u="sng">
                <a:solidFill>
                  <a:srgbClr val="000000"/>
                </a:solidFill>
                <a:uFillTx/>
                <a:latin typeface="Arial"/>
              </a:rPr>
              <a:t>7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     8     9    10  </a:t>
            </a:r>
            <a:r>
              <a:rPr b="0" lang="en-US" sz="1100" spc="-1" strike="noStrike" u="sng">
                <a:solidFill>
                  <a:srgbClr val="000000"/>
                </a:solidFill>
                <a:uFillTx/>
                <a:latin typeface="Arial"/>
              </a:rPr>
              <a:t>11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0" lang="en-US" sz="1100" spc="-1" strike="noStrike" u="sng">
                <a:solidFill>
                  <a:srgbClr val="000000"/>
                </a:solidFill>
                <a:uFillTx/>
                <a:latin typeface="Arial"/>
              </a:rPr>
              <a:t>12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    M      M     1   2     3     4      5     6     </a:t>
            </a:r>
            <a:r>
              <a:rPr b="0" lang="en-US" sz="1100" spc="-1" strike="noStrike" u="sng">
                <a:solidFill>
                  <a:srgbClr val="000000"/>
                </a:solidFill>
                <a:uFillTx/>
                <a:latin typeface="Arial"/>
              </a:rPr>
              <a:t>7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     8     9    10  </a:t>
            </a:r>
            <a:r>
              <a:rPr b="0" lang="en-US" sz="1100" spc="-1" strike="noStrike" u="sng">
                <a:solidFill>
                  <a:srgbClr val="000000"/>
                </a:solidFill>
                <a:uFillTx/>
                <a:latin typeface="Arial"/>
              </a:rPr>
              <a:t>11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100" spc="-1" strike="noStrike" u="sng">
                <a:solidFill>
                  <a:srgbClr val="000000"/>
                </a:solidFill>
                <a:uFillTx/>
                <a:latin typeface="Arial"/>
              </a:rPr>
              <a:t>12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    M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2495880" y="358920"/>
            <a:ext cx="459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(a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6796440" y="333360"/>
            <a:ext cx="459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(b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776160" y="4221000"/>
            <a:ext cx="8744040" cy="2284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2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Figure S2. Plasmid patterns of </a:t>
            </a:r>
            <a:r>
              <a:rPr b="1" i="1" lang="en-GB" sz="1200" spc="-1" strike="noStrike">
                <a:solidFill>
                  <a:srgbClr val="000000"/>
                </a:solidFill>
                <a:latin typeface="Arial"/>
              </a:rPr>
              <a:t>vanB2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i="1" lang="en-GB" sz="1200" spc="-1" strike="noStrike">
                <a:solidFill>
                  <a:srgbClr val="000000"/>
                </a:solidFill>
                <a:latin typeface="Arial"/>
              </a:rPr>
              <a:t>E. faecium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 outbreak and non-outbreak strains.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(a) Undigested plasmid patterns resolved in 0.8 % agarose gel; (b) Southern hybridisation with a labelled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vanB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probe. Underlined lane numbers designate “non-outbreak strains”. Legend: O, ST192 outbreak strain; NO, non-outbreak strains; M, Roche Size Marker III, DIG-labelled (for orientation purposes only); 1, UW7606(O); 2, UW7609(O); 3, UW7612(O); 4, UW7813(O); 5, UW7819(O); 6, UW7842(O); 7, UW7610 (NO, ST117); 8, UW7611(O, ST192); 9, UW7835 (O); 10, UW7845(O); 11, UW7852 (NO, ST203); 12, UW7859 (NO, ST203)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5" name=""/>
          <p:cNvGrpSpPr/>
          <p:nvPr/>
        </p:nvGrpSpPr>
        <p:grpSpPr>
          <a:xfrm>
            <a:off x="944640" y="1216080"/>
            <a:ext cx="3787560" cy="2735280"/>
            <a:chOff x="944640" y="1216080"/>
            <a:chExt cx="3787560" cy="2735280"/>
          </a:xfrm>
        </p:grpSpPr>
        <p:pic>
          <p:nvPicPr>
            <p:cNvPr id="46" name="" descr=""/>
            <p:cNvPicPr/>
            <p:nvPr/>
          </p:nvPicPr>
          <p:blipFill>
            <a:blip r:embed="rId1"/>
            <a:srcRect l="5265" t="4678" r="34235" b="6787"/>
            <a:stretch/>
          </p:blipFill>
          <p:spPr>
            <a:xfrm>
              <a:off x="944640" y="1216080"/>
              <a:ext cx="2689200" cy="2735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7" name="" descr=""/>
            <p:cNvPicPr/>
            <p:nvPr/>
          </p:nvPicPr>
          <p:blipFill>
            <a:blip r:embed="rId2"/>
            <a:srcRect l="71662" t="4678" r="3522" b="6787"/>
            <a:stretch/>
          </p:blipFill>
          <p:spPr>
            <a:xfrm>
              <a:off x="3629160" y="1216080"/>
              <a:ext cx="1103040" cy="273528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48" name=""/>
          <p:cNvGrpSpPr/>
          <p:nvPr/>
        </p:nvGrpSpPr>
        <p:grpSpPr>
          <a:xfrm>
            <a:off x="4745160" y="1217520"/>
            <a:ext cx="3779640" cy="2735280"/>
            <a:chOff x="4745160" y="1217520"/>
            <a:chExt cx="3779640" cy="2735280"/>
          </a:xfrm>
        </p:grpSpPr>
        <p:pic>
          <p:nvPicPr>
            <p:cNvPr id="49" name="" descr=""/>
            <p:cNvPicPr/>
            <p:nvPr/>
          </p:nvPicPr>
          <p:blipFill>
            <a:blip r:embed="rId3"/>
            <a:srcRect l="69091" t="6016" r="9434" b="16374"/>
            <a:stretch/>
          </p:blipFill>
          <p:spPr>
            <a:xfrm>
              <a:off x="7450200" y="1217520"/>
              <a:ext cx="1074600" cy="2735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0" name="" descr=""/>
            <p:cNvPicPr/>
            <p:nvPr/>
          </p:nvPicPr>
          <p:blipFill>
            <a:blip r:embed="rId4"/>
            <a:srcRect l="9469" t="6016" r="36441" b="16374"/>
            <a:stretch/>
          </p:blipFill>
          <p:spPr>
            <a:xfrm>
              <a:off x="4745160" y="1217520"/>
              <a:ext cx="2706480" cy="273528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1-09T09:40:19Z</dcterms:created>
  <dc:creator>wernerg</dc:creator>
  <dc:description/>
  <dc:language>en-US</dc:language>
  <cp:lastModifiedBy>wernerg</cp:lastModifiedBy>
  <dcterms:modified xsi:type="dcterms:W3CDTF">2012-04-12T12:16:35Z</dcterms:modified>
  <cp:revision>5</cp:revision>
  <dc:subject/>
  <dc:title>Folie 1</dc:title>
</cp:coreProperties>
</file>